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2">
  <p:sldMasterIdLst>
    <p:sldMasterId id="2147483648" r:id="rId4"/>
  </p:sldMasterIdLst>
  <p:sldIdLst>
    <p:sldId id="363" r:id="rId5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512" autoAdjust="0"/>
  </p:normalViewPr>
  <p:slideViewPr>
    <p:cSldViewPr>
      <p:cViewPr varScale="1">
        <p:scale>
          <a:sx n="102" d="100"/>
          <a:sy n="102" d="100"/>
        </p:scale>
        <p:origin x="-27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163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143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9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040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727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763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550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6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889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020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148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703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 Box 3">
            <a:extLst>
              <a:ext uri="{FF2B5EF4-FFF2-40B4-BE49-F238E27FC236}">
                <a16:creationId xmlns="" xmlns:a16="http://schemas.microsoft.com/office/drawing/2014/main" id="{C0936A8B-1C02-4AD4-9B3F-17969E41F3D0}"/>
              </a:ext>
            </a:extLst>
          </p:cNvPr>
          <p:cNvSpPr txBox="1">
            <a:spLocks noChangeArrowheads="1"/>
          </p:cNvSpPr>
          <p:nvPr/>
        </p:nvSpPr>
        <p:spPr bwMode="auto">
          <a:xfrm rot="-5392203">
            <a:off x="2667384" y="110343"/>
            <a:ext cx="670462" cy="32898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M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UVE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 err="1">
                <a:solidFill>
                  <a:srgbClr val="070605"/>
                </a:solidFill>
                <a:latin typeface="Arial" charset="0"/>
              </a:rPr>
              <a:t>PrEC</a:t>
            </a:r>
            <a:endParaRPr lang="en-US" altLang="en-US" sz="1200" dirty="0">
              <a:solidFill>
                <a:srgbClr val="070605"/>
              </a:solidFill>
              <a:latin typeface="Arial" charset="0"/>
            </a:endParaRP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UF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NHBE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ME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RE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RM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X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X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BT474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M</a:t>
            </a:r>
          </a:p>
        </p:txBody>
      </p:sp>
      <p:sp>
        <p:nvSpPr>
          <p:cNvPr id="25" name="Text Box 3">
            <a:extLst>
              <a:ext uri="{FF2B5EF4-FFF2-40B4-BE49-F238E27FC236}">
                <a16:creationId xmlns="" xmlns:a16="http://schemas.microsoft.com/office/drawing/2014/main" id="{C0477615-BD11-42D1-9FB3-B7692D527ACF}"/>
              </a:ext>
            </a:extLst>
          </p:cNvPr>
          <p:cNvSpPr txBox="1">
            <a:spLocks noChangeArrowheads="1"/>
          </p:cNvSpPr>
          <p:nvPr/>
        </p:nvSpPr>
        <p:spPr bwMode="auto">
          <a:xfrm rot="-5392203">
            <a:off x="6719905" y="490376"/>
            <a:ext cx="1297347" cy="16278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M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MCF10A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MVE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THLE-3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BT474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M</a:t>
            </a:r>
          </a:p>
        </p:txBody>
      </p:sp>
      <p:sp>
        <p:nvSpPr>
          <p:cNvPr id="26" name="Text Box 6">
            <a:extLst>
              <a:ext uri="{FF2B5EF4-FFF2-40B4-BE49-F238E27FC236}">
                <a16:creationId xmlns="" xmlns:a16="http://schemas.microsoft.com/office/drawing/2014/main" id="{DF403AD6-BA9A-4AB6-B9CB-1E59D7CCF0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3109" y="4004671"/>
            <a:ext cx="530637" cy="246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Acti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ABEB2E3A-3AC0-4403-8498-3906616E2559}"/>
              </a:ext>
            </a:extLst>
          </p:cNvPr>
          <p:cNvSpPr txBox="1"/>
          <p:nvPr/>
        </p:nvSpPr>
        <p:spPr>
          <a:xfrm>
            <a:off x="633937" y="1368594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AF86956A-9EB6-46F3-9A80-289B44B71CC2}"/>
              </a:ext>
            </a:extLst>
          </p:cNvPr>
          <p:cNvSpPr txBox="1"/>
          <p:nvPr/>
        </p:nvSpPr>
        <p:spPr>
          <a:xfrm>
            <a:off x="5618196" y="1493639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sp>
        <p:nvSpPr>
          <p:cNvPr id="5" name="Title 4">
            <a:extLst>
              <a:ext uri="{FF2B5EF4-FFF2-40B4-BE49-F238E27FC236}">
                <a16:creationId xmlns="" xmlns:a16="http://schemas.microsoft.com/office/drawing/2014/main" id="{E5482076-4091-4E5E-9B97-25B1B0B130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5588" y="123127"/>
            <a:ext cx="3188351" cy="418496"/>
          </a:xfrm>
        </p:spPr>
        <p:txBody>
          <a:bodyPr>
            <a:normAutofit fontScale="90000"/>
          </a:bodyPr>
          <a:lstStyle/>
          <a:p>
            <a:pPr algn="l"/>
            <a:r>
              <a:rPr lang="en-US" sz="3200" dirty="0"/>
              <a:t>Additional File 2</a:t>
            </a:r>
          </a:p>
        </p:txBody>
      </p:sp>
      <p:pic>
        <p:nvPicPr>
          <p:cNvPr id="4" name="Picture 3" descr="A picture containing indoor, kitchen, sitting, photo&#10;&#10;Description automatically generated">
            <a:extLst>
              <a:ext uri="{FF2B5EF4-FFF2-40B4-BE49-F238E27FC236}">
                <a16:creationId xmlns="" xmlns:a16="http://schemas.microsoft.com/office/drawing/2014/main" id="{ABAF767E-FAF0-41E4-BF6D-95F6C2F9120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2766"/>
          <a:stretch/>
        </p:blipFill>
        <p:spPr>
          <a:xfrm>
            <a:off x="6483081" y="2039623"/>
            <a:ext cx="1746519" cy="3522977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="" xmlns:a16="http://schemas.microsoft.com/office/drawing/2014/main" id="{6A0459FB-8986-42E5-A382-AB84290A5186}"/>
              </a:ext>
            </a:extLst>
          </p:cNvPr>
          <p:cNvCxnSpPr>
            <a:cxnSpLocks/>
          </p:cNvCxnSpPr>
          <p:nvPr/>
        </p:nvCxnSpPr>
        <p:spPr>
          <a:xfrm>
            <a:off x="6266633" y="4127780"/>
            <a:ext cx="21905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 descr="A picture containing photo, looking, bird, hanging&#10;&#10;Description automatically generated">
            <a:extLst>
              <a:ext uri="{FF2B5EF4-FFF2-40B4-BE49-F238E27FC236}">
                <a16:creationId xmlns="" xmlns:a16="http://schemas.microsoft.com/office/drawing/2014/main" id="{6FC34D44-A8CC-4FAD-87B3-BD84D52AAE1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933" b="50000"/>
          <a:stretch/>
        </p:blipFill>
        <p:spPr>
          <a:xfrm>
            <a:off x="1066799" y="2136671"/>
            <a:ext cx="3704841" cy="3318406"/>
          </a:xfrm>
          <a:prstGeom prst="rect">
            <a:avLst/>
          </a:prstGeom>
        </p:spPr>
      </p:pic>
      <p:sp>
        <p:nvSpPr>
          <p:cNvPr id="42" name="Text Box 6">
            <a:extLst>
              <a:ext uri="{FF2B5EF4-FFF2-40B4-BE49-F238E27FC236}">
                <a16:creationId xmlns="" xmlns:a16="http://schemas.microsoft.com/office/drawing/2014/main" id="{B6205474-BA77-4A1F-8560-1742AF6C99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2782" y="4127781"/>
            <a:ext cx="530637" cy="246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Actin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="" xmlns:a16="http://schemas.microsoft.com/office/drawing/2014/main" id="{41026174-693C-4865-89D1-ADB839BF9368}"/>
              </a:ext>
            </a:extLst>
          </p:cNvPr>
          <p:cNvCxnSpPr>
            <a:cxnSpLocks/>
          </p:cNvCxnSpPr>
          <p:nvPr/>
        </p:nvCxnSpPr>
        <p:spPr>
          <a:xfrm>
            <a:off x="846306" y="4250890"/>
            <a:ext cx="21905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 Box 6">
            <a:extLst>
              <a:ext uri="{FF2B5EF4-FFF2-40B4-BE49-F238E27FC236}">
                <a16:creationId xmlns="" xmlns:a16="http://schemas.microsoft.com/office/drawing/2014/main" id="{95417A67-940D-4A20-88E9-8E854E5465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83924" y="3184460"/>
            <a:ext cx="642336" cy="246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PRLR 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="" xmlns:a16="http://schemas.microsoft.com/office/drawing/2014/main" id="{A1B42D5C-92F2-4F0E-A0A8-2E5A70ADAEC2}"/>
              </a:ext>
            </a:extLst>
          </p:cNvPr>
          <p:cNvCxnSpPr>
            <a:cxnSpLocks/>
          </p:cNvCxnSpPr>
          <p:nvPr/>
        </p:nvCxnSpPr>
        <p:spPr>
          <a:xfrm flipH="1">
            <a:off x="4746811" y="3307570"/>
            <a:ext cx="21905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EAAFEF77-307F-4916-9844-99BA7C6E2818}"/>
              </a:ext>
            </a:extLst>
          </p:cNvPr>
          <p:cNvSpPr txBox="1"/>
          <p:nvPr/>
        </p:nvSpPr>
        <p:spPr>
          <a:xfrm>
            <a:off x="189722" y="5991148"/>
            <a:ext cx="8763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igure S2. Full Western blots from S1. Panels A and B: M are markers, X are irrelevant cell lines, and remaining  lanes as in S1</a:t>
            </a:r>
          </a:p>
        </p:txBody>
      </p:sp>
      <p:sp>
        <p:nvSpPr>
          <p:cNvPr id="47" name="Text Box 6">
            <a:extLst>
              <a:ext uri="{FF2B5EF4-FFF2-40B4-BE49-F238E27FC236}">
                <a16:creationId xmlns="" xmlns:a16="http://schemas.microsoft.com/office/drawing/2014/main" id="{2C188D3C-DD4D-4413-BF39-3AAA4984D8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50392" y="3030523"/>
            <a:ext cx="642336" cy="246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PRLR 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="" xmlns:a16="http://schemas.microsoft.com/office/drawing/2014/main" id="{F0F5F948-5A06-42C3-B826-BF27F1073590}"/>
              </a:ext>
            </a:extLst>
          </p:cNvPr>
          <p:cNvCxnSpPr>
            <a:cxnSpLocks/>
          </p:cNvCxnSpPr>
          <p:nvPr/>
        </p:nvCxnSpPr>
        <p:spPr>
          <a:xfrm flipH="1">
            <a:off x="8113279" y="3153633"/>
            <a:ext cx="21905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98113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B0CF84F26448948B3776880BD2CECA2" ma:contentTypeVersion="13" ma:contentTypeDescription="Create a new document." ma:contentTypeScope="" ma:versionID="28453d955f20ff1b64a741be3868ff95">
  <xsd:schema xmlns:xsd="http://www.w3.org/2001/XMLSchema" xmlns:xs="http://www.w3.org/2001/XMLSchema" xmlns:p="http://schemas.microsoft.com/office/2006/metadata/properties" xmlns:ns3="092a72bf-8f60-447c-a6a9-040ed33d2700" xmlns:ns4="2ea18bd6-9f6c-4142-bf2d-c8961101155f" targetNamespace="http://schemas.microsoft.com/office/2006/metadata/properties" ma:root="true" ma:fieldsID="9443dec78999676a320a9e909f75c3be" ns3:_="" ns4:_="">
    <xsd:import namespace="092a72bf-8f60-447c-a6a9-040ed33d2700"/>
    <xsd:import namespace="2ea18bd6-9f6c-4142-bf2d-c8961101155f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2a72bf-8f60-447c-a6a9-040ed33d270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ea18bd6-9f6c-4142-bf2d-c8961101155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87798D7-FDE7-4A58-BF84-5219781105D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352F143-82FC-4B7F-96E3-D15E3D3DD244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microsoft.com/office/2006/documentManagement/types"/>
    <ds:schemaRef ds:uri="2ea18bd6-9f6c-4142-bf2d-c8961101155f"/>
    <ds:schemaRef ds:uri="http://schemas.openxmlformats.org/package/2006/metadata/core-properties"/>
    <ds:schemaRef ds:uri="092a72bf-8f60-447c-a6a9-040ed33d2700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61E5D2E0-B8D4-4BD9-BDA3-30DFACE3E88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2a72bf-8f60-447c-a6a9-040ed33d2700"/>
    <ds:schemaRef ds:uri="2ea18bd6-9f6c-4142-bf2d-c8961101155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122</TotalTime>
  <Words>57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dditional File 2</vt:lpstr>
    </vt:vector>
  </TitlesOfParts>
  <Company>AbbVie In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ABBV-176 paper</dc:title>
  <dc:creator>Anderson, Mark G</dc:creator>
  <cp:lastModifiedBy>RTORRES</cp:lastModifiedBy>
  <cp:revision>81</cp:revision>
  <cp:lastPrinted>2019-12-04T23:33:06Z</cp:lastPrinted>
  <dcterms:created xsi:type="dcterms:W3CDTF">2018-10-23T16:01:28Z</dcterms:created>
  <dcterms:modified xsi:type="dcterms:W3CDTF">2021-05-25T14:22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B0CF84F26448948B3776880BD2CECA2</vt:lpwstr>
  </property>
</Properties>
</file>